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D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9" d="100"/>
          <a:sy n="69" d="100"/>
        </p:scale>
        <p:origin x="78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9373292-9FFA-4B3F-A1FF-5A14C21339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fr-DZ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D2C20D2-4AF7-4594-9769-8B8AC00192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fr-DZ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3D7253A-9FB7-4AEB-A23B-4877AD70F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2BF65-DCCF-4887-8B3E-729B233A7B93}" type="datetimeFigureOut">
              <a:rPr lang="fr-DZ" smtClean="0"/>
              <a:t>09/22/2024</a:t>
            </a:fld>
            <a:endParaRPr lang="fr-DZ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B02AE96-7A63-4408-B1F8-0495BA88D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DZ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4D81C0B-EDAF-4156-89B1-00C072922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B539D-332F-4B30-B660-E138C8955E91}" type="slidenum">
              <a:rPr lang="fr-DZ" smtClean="0"/>
              <a:t>‹#›</a:t>
            </a:fld>
            <a:endParaRPr lang="fr-DZ"/>
          </a:p>
        </p:txBody>
      </p:sp>
    </p:spTree>
    <p:extLst>
      <p:ext uri="{BB962C8B-B14F-4D97-AF65-F5344CB8AC3E}">
        <p14:creationId xmlns:p14="http://schemas.microsoft.com/office/powerpoint/2010/main" val="414754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E58BA04-9C2F-442D-A80B-8FF7B19C7E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DZ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C30B350-552B-4384-9768-1CE7E8E04D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DZ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6007380-A13E-490E-A147-924EDB1F0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2BF65-DCCF-4887-8B3E-729B233A7B93}" type="datetimeFigureOut">
              <a:rPr lang="fr-DZ" smtClean="0"/>
              <a:t>09/22/2024</a:t>
            </a:fld>
            <a:endParaRPr lang="fr-DZ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121F57F-6295-431F-A1AC-FC541687C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DZ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0803FC4-752B-4E97-9120-053C51FDFE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B539D-332F-4B30-B660-E138C8955E91}" type="slidenum">
              <a:rPr lang="fr-DZ" smtClean="0"/>
              <a:t>‹#›</a:t>
            </a:fld>
            <a:endParaRPr lang="fr-DZ"/>
          </a:p>
        </p:txBody>
      </p:sp>
    </p:spTree>
    <p:extLst>
      <p:ext uri="{BB962C8B-B14F-4D97-AF65-F5344CB8AC3E}">
        <p14:creationId xmlns:p14="http://schemas.microsoft.com/office/powerpoint/2010/main" val="2712749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7416EBF6-1F44-4E64-93B3-6C817536D9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fr-DZ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09316C1-5831-45D6-9287-C75322737C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DZ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291328A-4F33-4F4C-88A5-6D7AEADBEA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2BF65-DCCF-4887-8B3E-729B233A7B93}" type="datetimeFigureOut">
              <a:rPr lang="fr-DZ" smtClean="0"/>
              <a:t>09/22/2024</a:t>
            </a:fld>
            <a:endParaRPr lang="fr-DZ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6EEA981-09B0-4DC7-8AD1-361B5371B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DZ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FE65197-F93A-42E0-8162-520FD47E1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B539D-332F-4B30-B660-E138C8955E91}" type="slidenum">
              <a:rPr lang="fr-DZ" smtClean="0"/>
              <a:t>‹#›</a:t>
            </a:fld>
            <a:endParaRPr lang="fr-DZ"/>
          </a:p>
        </p:txBody>
      </p:sp>
    </p:spTree>
    <p:extLst>
      <p:ext uri="{BB962C8B-B14F-4D97-AF65-F5344CB8AC3E}">
        <p14:creationId xmlns:p14="http://schemas.microsoft.com/office/powerpoint/2010/main" val="769263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7B89FCF-0B31-4E9B-B23E-2434B84E26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DZ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3D417E0-F6D4-43E4-974B-C8BD466D0F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DZ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B029048-B89E-440D-AE95-308143BB4A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2BF65-DCCF-4887-8B3E-729B233A7B93}" type="datetimeFigureOut">
              <a:rPr lang="fr-DZ" smtClean="0"/>
              <a:t>09/22/2024</a:t>
            </a:fld>
            <a:endParaRPr lang="fr-DZ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F892273-CCDE-4E7C-8800-0B8F9BA5E6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DZ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AD904F9-95E7-4D8C-8E7E-8510CE877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B539D-332F-4B30-B660-E138C8955E91}" type="slidenum">
              <a:rPr lang="fr-DZ" smtClean="0"/>
              <a:t>‹#›</a:t>
            </a:fld>
            <a:endParaRPr lang="fr-DZ"/>
          </a:p>
        </p:txBody>
      </p:sp>
    </p:spTree>
    <p:extLst>
      <p:ext uri="{BB962C8B-B14F-4D97-AF65-F5344CB8AC3E}">
        <p14:creationId xmlns:p14="http://schemas.microsoft.com/office/powerpoint/2010/main" val="37713467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07E8BA2-8382-43AC-B1DE-AAB6C6EE0E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fr-DZ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C591D29-3D33-448A-9B77-51603F45E0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DFF5D5A-C936-476C-92BC-67B0656A47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2BF65-DCCF-4887-8B3E-729B233A7B93}" type="datetimeFigureOut">
              <a:rPr lang="fr-DZ" smtClean="0"/>
              <a:t>09/22/2024</a:t>
            </a:fld>
            <a:endParaRPr lang="fr-DZ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6BA88A7-CFF3-4AFF-9B66-AD01BFE89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DZ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C4DBB92-2E2A-4673-9DF8-ED93BFA44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B539D-332F-4B30-B660-E138C8955E91}" type="slidenum">
              <a:rPr lang="fr-DZ" smtClean="0"/>
              <a:t>‹#›</a:t>
            </a:fld>
            <a:endParaRPr lang="fr-DZ"/>
          </a:p>
        </p:txBody>
      </p:sp>
    </p:spTree>
    <p:extLst>
      <p:ext uri="{BB962C8B-B14F-4D97-AF65-F5344CB8AC3E}">
        <p14:creationId xmlns:p14="http://schemas.microsoft.com/office/powerpoint/2010/main" val="3667332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BBCE8C-8C1C-4A4D-924C-3495B9E2C0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DZ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1794B01-8DB4-41F5-A1AF-176AEB19A0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DZ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A58C04A-D1A5-47D0-8006-C74149D5B2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DZ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D4948C4-BD29-4AEC-B09E-6A466CCBDF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2BF65-DCCF-4887-8B3E-729B233A7B93}" type="datetimeFigureOut">
              <a:rPr lang="fr-DZ" smtClean="0"/>
              <a:t>09/22/2024</a:t>
            </a:fld>
            <a:endParaRPr lang="fr-DZ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541E6A5-A475-4036-9FF2-29FCCCCD8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DZ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253D15A-A551-4788-B1D9-45A14CA73B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B539D-332F-4B30-B660-E138C8955E91}" type="slidenum">
              <a:rPr lang="fr-DZ" smtClean="0"/>
              <a:t>‹#›</a:t>
            </a:fld>
            <a:endParaRPr lang="fr-DZ"/>
          </a:p>
        </p:txBody>
      </p:sp>
    </p:spTree>
    <p:extLst>
      <p:ext uri="{BB962C8B-B14F-4D97-AF65-F5344CB8AC3E}">
        <p14:creationId xmlns:p14="http://schemas.microsoft.com/office/powerpoint/2010/main" val="284760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F9D4D24-34CF-47A1-95EA-8E0BDE99BB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fr-DZ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A11FA09-003A-46E4-91EF-A2DEBCB2FA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A42256F-EED2-4650-A4BD-EE688B796E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DZ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2EE46A8-E6B7-4612-97A4-CA1AC05F32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85F41C6B-00B1-4D47-BBD7-2A55E01142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DZ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FF7D39EA-0B75-44A8-B6D8-70003CC58B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2BF65-DCCF-4887-8B3E-729B233A7B93}" type="datetimeFigureOut">
              <a:rPr lang="fr-DZ" smtClean="0"/>
              <a:t>09/22/2024</a:t>
            </a:fld>
            <a:endParaRPr lang="fr-DZ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81D043DA-2C35-49DA-9657-E8C6FBB6DB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DZ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E8B4AC7-026B-4F03-B156-FCC0E3F65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B539D-332F-4B30-B660-E138C8955E91}" type="slidenum">
              <a:rPr lang="fr-DZ" smtClean="0"/>
              <a:t>‹#›</a:t>
            </a:fld>
            <a:endParaRPr lang="fr-DZ"/>
          </a:p>
        </p:txBody>
      </p:sp>
    </p:spTree>
    <p:extLst>
      <p:ext uri="{BB962C8B-B14F-4D97-AF65-F5344CB8AC3E}">
        <p14:creationId xmlns:p14="http://schemas.microsoft.com/office/powerpoint/2010/main" val="3362631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09136DE-B0B9-4D99-B1AD-52B84CAA60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DZ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2DD1508B-E742-4D9A-93CD-ED77272A0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2BF65-DCCF-4887-8B3E-729B233A7B93}" type="datetimeFigureOut">
              <a:rPr lang="fr-DZ" smtClean="0"/>
              <a:t>09/22/2024</a:t>
            </a:fld>
            <a:endParaRPr lang="fr-DZ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5BE501E-8A5F-4798-A2DD-205E8E363A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DZ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3E5E238-74CD-401F-96D7-2E5EB754CB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B539D-332F-4B30-B660-E138C8955E91}" type="slidenum">
              <a:rPr lang="fr-DZ" smtClean="0"/>
              <a:t>‹#›</a:t>
            </a:fld>
            <a:endParaRPr lang="fr-DZ"/>
          </a:p>
        </p:txBody>
      </p:sp>
    </p:spTree>
    <p:extLst>
      <p:ext uri="{BB962C8B-B14F-4D97-AF65-F5344CB8AC3E}">
        <p14:creationId xmlns:p14="http://schemas.microsoft.com/office/powerpoint/2010/main" val="908833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69D82EBD-AD3A-4DB4-90A5-1E0E97BE41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2BF65-DCCF-4887-8B3E-729B233A7B93}" type="datetimeFigureOut">
              <a:rPr lang="fr-DZ" smtClean="0"/>
              <a:t>09/22/2024</a:t>
            </a:fld>
            <a:endParaRPr lang="fr-DZ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88820CE-A807-4900-BE96-485AF0964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DZ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2D02BD6A-5EA1-4ABF-9286-89E65133F3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B539D-332F-4B30-B660-E138C8955E91}" type="slidenum">
              <a:rPr lang="fr-DZ" smtClean="0"/>
              <a:t>‹#›</a:t>
            </a:fld>
            <a:endParaRPr lang="fr-DZ"/>
          </a:p>
        </p:txBody>
      </p:sp>
    </p:spTree>
    <p:extLst>
      <p:ext uri="{BB962C8B-B14F-4D97-AF65-F5344CB8AC3E}">
        <p14:creationId xmlns:p14="http://schemas.microsoft.com/office/powerpoint/2010/main" val="2506549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02B33D9-09CF-431A-B61A-AB8FCA5D12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DZ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3DFD138-41DE-46F5-816B-68B01AD3F4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DZ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18D789F-C238-4576-A222-CF50F49615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2587FE1-401B-4CAA-BA4E-C8482B16E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2BF65-DCCF-4887-8B3E-729B233A7B93}" type="datetimeFigureOut">
              <a:rPr lang="fr-DZ" smtClean="0"/>
              <a:t>09/22/2024</a:t>
            </a:fld>
            <a:endParaRPr lang="fr-DZ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02C4089-430A-4074-9F30-488E2AADBC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DZ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48DEB22-88CB-4CCA-9864-B50E185359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B539D-332F-4B30-B660-E138C8955E91}" type="slidenum">
              <a:rPr lang="fr-DZ" smtClean="0"/>
              <a:t>‹#›</a:t>
            </a:fld>
            <a:endParaRPr lang="fr-DZ"/>
          </a:p>
        </p:txBody>
      </p:sp>
    </p:spTree>
    <p:extLst>
      <p:ext uri="{BB962C8B-B14F-4D97-AF65-F5344CB8AC3E}">
        <p14:creationId xmlns:p14="http://schemas.microsoft.com/office/powerpoint/2010/main" val="3294992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6921907-914F-4915-ACE7-34ADD8C44A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DZ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F4790335-63BE-45A0-9170-08A4CF575D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DZ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8674E5D-A039-4A29-9F38-37A03B3804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2C96AA0-7CB6-40E0-AA71-CCC59D7268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2BF65-DCCF-4887-8B3E-729B233A7B93}" type="datetimeFigureOut">
              <a:rPr lang="fr-DZ" smtClean="0"/>
              <a:t>09/22/2024</a:t>
            </a:fld>
            <a:endParaRPr lang="fr-DZ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EEBF666-C32B-4E31-A05B-9D9A6E69F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DZ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AB0BAEA-0DCB-4EB1-BCFB-6C401CBD1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B539D-332F-4B30-B660-E138C8955E91}" type="slidenum">
              <a:rPr lang="fr-DZ" smtClean="0"/>
              <a:t>‹#›</a:t>
            </a:fld>
            <a:endParaRPr lang="fr-DZ"/>
          </a:p>
        </p:txBody>
      </p:sp>
    </p:spTree>
    <p:extLst>
      <p:ext uri="{BB962C8B-B14F-4D97-AF65-F5344CB8AC3E}">
        <p14:creationId xmlns:p14="http://schemas.microsoft.com/office/powerpoint/2010/main" val="135631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F33A3392-5D86-4603-9D67-853F4D34DA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fr-DZ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CCD2F4A-4F83-46F7-A9E6-9CF874BDE3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DZ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6EF4371-48B6-4811-AAD5-71666A219C6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2BF65-DCCF-4887-8B3E-729B233A7B93}" type="datetimeFigureOut">
              <a:rPr lang="fr-DZ" smtClean="0"/>
              <a:t>09/22/2024</a:t>
            </a:fld>
            <a:endParaRPr lang="fr-DZ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9498ECA-51EF-415C-A35F-BC5B87E715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DZ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D26FF53-123B-4F48-96B0-3AFCD8808C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6B539D-332F-4B30-B660-E138C8955E91}" type="slidenum">
              <a:rPr lang="fr-DZ" smtClean="0"/>
              <a:t>‹#›</a:t>
            </a:fld>
            <a:endParaRPr lang="fr-DZ"/>
          </a:p>
        </p:txBody>
      </p:sp>
    </p:spTree>
    <p:extLst>
      <p:ext uri="{BB962C8B-B14F-4D97-AF65-F5344CB8AC3E}">
        <p14:creationId xmlns:p14="http://schemas.microsoft.com/office/powerpoint/2010/main" val="107779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D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FAC85D1-6ED0-D9A3-F221-1FFB7C056C0D}"/>
              </a:ext>
            </a:extLst>
          </p:cNvPr>
          <p:cNvGrpSpPr/>
          <p:nvPr/>
        </p:nvGrpSpPr>
        <p:grpSpPr>
          <a:xfrm>
            <a:off x="219239" y="95589"/>
            <a:ext cx="12022939" cy="6692103"/>
            <a:chOff x="219239" y="95589"/>
            <a:chExt cx="12022939" cy="6692103"/>
          </a:xfrm>
        </p:grpSpPr>
        <p:pic>
          <p:nvPicPr>
            <p:cNvPr id="10" name="Picture 2">
              <a:extLst>
                <a:ext uri="{FF2B5EF4-FFF2-40B4-BE49-F238E27FC236}">
                  <a16:creationId xmlns:a16="http://schemas.microsoft.com/office/drawing/2014/main" id="{44D60579-80F7-C8BF-4642-5F01B40500B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941" r="16941"/>
            <a:stretch/>
          </p:blipFill>
          <p:spPr bwMode="auto">
            <a:xfrm>
              <a:off x="328398" y="3396247"/>
              <a:ext cx="2780006" cy="339144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Image 8">
              <a:extLst>
                <a:ext uri="{FF2B5EF4-FFF2-40B4-BE49-F238E27FC236}">
                  <a16:creationId xmlns:a16="http://schemas.microsoft.com/office/drawing/2014/main" id="{A15CBD9D-DA4B-4D1C-8790-E79E6D6852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057" t="25107" r="8057" b="22912"/>
            <a:stretch/>
          </p:blipFill>
          <p:spPr>
            <a:xfrm>
              <a:off x="4152855" y="550837"/>
              <a:ext cx="2996090" cy="2552802"/>
            </a:xfrm>
            <a:prstGeom prst="rect">
              <a:avLst/>
            </a:prstGeom>
          </p:spPr>
        </p:pic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C709B9A5-D315-4CEB-A6A5-D0D0156B7E83}"/>
                </a:ext>
              </a:extLst>
            </p:cNvPr>
            <p:cNvSpPr txBox="1"/>
            <p:nvPr/>
          </p:nvSpPr>
          <p:spPr>
            <a:xfrm>
              <a:off x="4303279" y="150722"/>
              <a:ext cx="25012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dirty="0">
                  <a:latin typeface="Arial" panose="020B0604020202020204" pitchFamily="34" charset="0"/>
                  <a:cs typeface="Arial" panose="020B0604020202020204" pitchFamily="34" charset="0"/>
                </a:rPr>
                <a:t>GC-MS </a:t>
              </a:r>
              <a:r>
                <a:rPr lang="en-AU" sz="2000" dirty="0"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  <a:r>
                <a:rPr lang="fr-FR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DZ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28" name="Picture 4" descr="Peanuts White Background&quot; Images – Browse 8 Stock Photos, Vectors, and  Video | Adobe Stock">
              <a:extLst>
                <a:ext uri="{FF2B5EF4-FFF2-40B4-BE49-F238E27FC236}">
                  <a16:creationId xmlns:a16="http://schemas.microsoft.com/office/drawing/2014/main" id="{61A3B044-DBDE-FF16-FD5A-2FEBDD0DF94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239" y="352127"/>
              <a:ext cx="3756365" cy="2504243"/>
            </a:xfrm>
            <a:prstGeom prst="ellipse">
              <a:avLst/>
            </a:prstGeom>
            <a:ln>
              <a:noFill/>
            </a:ln>
            <a:effectLst>
              <a:softEdge rad="112500"/>
            </a:effectLst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ZoneTexte 80">
              <a:extLst>
                <a:ext uri="{FF2B5EF4-FFF2-40B4-BE49-F238E27FC236}">
                  <a16:creationId xmlns:a16="http://schemas.microsoft.com/office/drawing/2014/main" id="{2F04C74B-428E-45E1-B599-977BBDA608D5}"/>
                </a:ext>
              </a:extLst>
            </p:cNvPr>
            <p:cNvSpPr txBox="1"/>
            <p:nvPr/>
          </p:nvSpPr>
          <p:spPr>
            <a:xfrm>
              <a:off x="389196" y="500660"/>
              <a:ext cx="1691813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2500" dirty="0" err="1">
                  <a:latin typeface="Arial" panose="020B0604020202020204" pitchFamily="34" charset="0"/>
                  <a:cs typeface="Arial" panose="020B0604020202020204" pitchFamily="34" charset="0"/>
                </a:rPr>
                <a:t>Peanut</a:t>
              </a:r>
              <a:endParaRPr lang="fr-DZ" sz="2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0" name="Picture 6">
              <a:extLst>
                <a:ext uri="{FF2B5EF4-FFF2-40B4-BE49-F238E27FC236}">
                  <a16:creationId xmlns:a16="http://schemas.microsoft.com/office/drawing/2014/main" id="{B1D90682-07CD-D61C-D797-577675A56CA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19726" y="3735391"/>
              <a:ext cx="5391892" cy="28127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80">
              <a:extLst>
                <a:ext uri="{FF2B5EF4-FFF2-40B4-BE49-F238E27FC236}">
                  <a16:creationId xmlns:a16="http://schemas.microsoft.com/office/drawing/2014/main" id="{B7629878-66AD-5BBD-7015-B5AC9DB8961A}"/>
                </a:ext>
              </a:extLst>
            </p:cNvPr>
            <p:cNvSpPr txBox="1"/>
            <p:nvPr/>
          </p:nvSpPr>
          <p:spPr>
            <a:xfrm>
              <a:off x="219239" y="3028890"/>
              <a:ext cx="289645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2000" dirty="0">
                  <a:latin typeface="Arial" panose="020B0604020202020204" pitchFamily="34" charset="0"/>
                  <a:cs typeface="Arial" panose="020B0604020202020204" pitchFamily="34" charset="0"/>
                </a:rPr>
                <a:t>Extraction </a:t>
              </a:r>
              <a:r>
                <a:rPr lang="fr-FR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with</a:t>
              </a:r>
              <a:r>
                <a:rPr lang="fr-FR" sz="2000" dirty="0">
                  <a:latin typeface="Arial" panose="020B0604020202020204" pitchFamily="34" charset="0"/>
                  <a:cs typeface="Arial" panose="020B0604020202020204" pitchFamily="34" charset="0"/>
                </a:rPr>
                <a:t> hexane</a:t>
              </a:r>
              <a:endParaRPr lang="fr-DZ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ZoneTexte 54">
              <a:extLst>
                <a:ext uri="{FF2B5EF4-FFF2-40B4-BE49-F238E27FC236}">
                  <a16:creationId xmlns:a16="http://schemas.microsoft.com/office/drawing/2014/main" id="{2EFEC796-8628-4E9D-BAD1-7C487516D60B}"/>
                </a:ext>
              </a:extLst>
            </p:cNvPr>
            <p:cNvSpPr txBox="1"/>
            <p:nvPr/>
          </p:nvSpPr>
          <p:spPr>
            <a:xfrm>
              <a:off x="4152855" y="3248195"/>
              <a:ext cx="280212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2000" i="1" dirty="0">
                  <a:latin typeface="Arial" panose="020B0604020202020204" pitchFamily="34" charset="0"/>
                  <a:cs typeface="Arial" panose="020B0604020202020204" pitchFamily="34" charset="0"/>
                </a:rPr>
                <a:t>Antioxidant </a:t>
              </a:r>
              <a:r>
                <a:rPr lang="en-ZA" sz="2000" dirty="0">
                  <a:latin typeface="Arial" panose="020B0604020202020204" pitchFamily="34" charset="0"/>
                  <a:cs typeface="Arial" panose="020B0604020202020204" pitchFamily="34" charset="0"/>
                </a:rPr>
                <a:t>Assays </a:t>
              </a:r>
            </a:p>
          </p:txBody>
        </p:sp>
        <p:sp>
          <p:nvSpPr>
            <p:cNvPr id="15" name="ZoneTexte 78">
              <a:extLst>
                <a:ext uri="{FF2B5EF4-FFF2-40B4-BE49-F238E27FC236}">
                  <a16:creationId xmlns:a16="http://schemas.microsoft.com/office/drawing/2014/main" id="{87601FA2-CF37-431F-A13D-9EE6C4C203F4}"/>
                </a:ext>
              </a:extLst>
            </p:cNvPr>
            <p:cNvSpPr txBox="1"/>
            <p:nvPr/>
          </p:nvSpPr>
          <p:spPr>
            <a:xfrm>
              <a:off x="7849357" y="95589"/>
              <a:ext cx="412340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sz="2000" i="1" dirty="0">
                  <a:latin typeface="Arial" panose="020B0604020202020204" pitchFamily="34" charset="0"/>
                  <a:cs typeface="Arial" panose="020B0604020202020204" pitchFamily="34" charset="0"/>
                </a:rPr>
                <a:t>In Silico </a:t>
              </a:r>
              <a:r>
                <a:rPr lang="en-ZA" sz="2000" dirty="0">
                  <a:latin typeface="Arial" panose="020B0604020202020204" pitchFamily="34" charset="0"/>
                  <a:cs typeface="Arial" panose="020B0604020202020204" pitchFamily="34" charset="0"/>
                </a:rPr>
                <a:t>Assay (</a:t>
              </a:r>
              <a:r>
                <a:rPr lang="en-US" sz="2000" b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nti-Alzheimer's</a:t>
              </a:r>
              <a:r>
                <a:rPr lang="en-ZA" sz="2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0A0DD34D-E622-E16D-D15E-F5BB450CD6A6}"/>
                </a:ext>
              </a:extLst>
            </p:cNvPr>
            <p:cNvSpPr/>
            <p:nvPr/>
          </p:nvSpPr>
          <p:spPr>
            <a:xfrm>
              <a:off x="4862945" y="4352355"/>
              <a:ext cx="554182" cy="5936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" name="Image 7">
              <a:extLst>
                <a:ext uri="{FF2B5EF4-FFF2-40B4-BE49-F238E27FC236}">
                  <a16:creationId xmlns:a16="http://schemas.microsoft.com/office/drawing/2014/main" id="{A8676140-EC98-6EAD-729C-AF961C4E980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8339328" y="689804"/>
              <a:ext cx="3283367" cy="26953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" name="Image 10">
              <a:extLst>
                <a:ext uri="{FF2B5EF4-FFF2-40B4-BE49-F238E27FC236}">
                  <a16:creationId xmlns:a16="http://schemas.microsoft.com/office/drawing/2014/main" id="{6F44B955-35C1-F20D-9B3F-35F29C91EC8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8430269" y="3829377"/>
              <a:ext cx="2992408" cy="24599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A8B8166-6E23-3635-44E1-23570D87D985}"/>
                </a:ext>
              </a:extLst>
            </p:cNvPr>
            <p:cNvSpPr txBox="1"/>
            <p:nvPr/>
          </p:nvSpPr>
          <p:spPr>
            <a:xfrm>
              <a:off x="7882867" y="3448250"/>
              <a:ext cx="4196288" cy="35394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700" dirty="0">
                  <a:effectLst/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Galantamine </a:t>
              </a:r>
              <a:r>
                <a:rPr lang="en-GB" sz="1700" dirty="0">
                  <a:latin typeface="Arial" panose="020B0604020202020204" pitchFamily="34" charset="0"/>
                  <a:cs typeface="Arial" panose="020B0604020202020204" pitchFamily="34" charset="0"/>
                </a:rPr>
                <a:t>into the </a:t>
              </a:r>
              <a:r>
                <a:rPr lang="en-GB" sz="1700" dirty="0" err="1">
                  <a:latin typeface="Arial" panose="020B0604020202020204" pitchFamily="34" charset="0"/>
                  <a:cs typeface="Arial" panose="020B0604020202020204" pitchFamily="34" charset="0"/>
                </a:rPr>
                <a:t>BChE</a:t>
              </a:r>
              <a:r>
                <a:rPr lang="en-GB" sz="1700" dirty="0">
                  <a:latin typeface="Arial" panose="020B0604020202020204" pitchFamily="34" charset="0"/>
                  <a:cs typeface="Arial" panose="020B0604020202020204" pitchFamily="34" charset="0"/>
                </a:rPr>
                <a:t> Active Site</a:t>
              </a:r>
              <a:endParaRPr lang="en-US" sz="1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753975A4-42D5-7EEF-1311-741221A31D94}"/>
                </a:ext>
              </a:extLst>
            </p:cNvPr>
            <p:cNvSpPr txBox="1"/>
            <p:nvPr/>
          </p:nvSpPr>
          <p:spPr>
            <a:xfrm>
              <a:off x="6664036" y="6388323"/>
              <a:ext cx="5578142" cy="3539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700" dirty="0">
                  <a:effectLst/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6-Methyl </a:t>
              </a:r>
              <a:r>
                <a:rPr lang="en-US" sz="1700" dirty="0" err="1">
                  <a:effectLst/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Octahydro</a:t>
              </a:r>
              <a:r>
                <a:rPr lang="en-US" sz="1700" dirty="0">
                  <a:effectLst/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-Coumarin </a:t>
              </a:r>
              <a:r>
                <a:rPr lang="en-GB" sz="1700" dirty="0">
                  <a:latin typeface="Arial" panose="020B0604020202020204" pitchFamily="34" charset="0"/>
                  <a:cs typeface="Arial" panose="020B0604020202020204" pitchFamily="34" charset="0"/>
                </a:rPr>
                <a:t>into the </a:t>
              </a:r>
              <a:r>
                <a:rPr lang="en-GB" sz="1700" dirty="0" err="1">
                  <a:latin typeface="Arial" panose="020B0604020202020204" pitchFamily="34" charset="0"/>
                  <a:cs typeface="Arial" panose="020B0604020202020204" pitchFamily="34" charset="0"/>
                </a:rPr>
                <a:t>BChE</a:t>
              </a:r>
              <a:r>
                <a:rPr lang="en-GB" sz="1700" dirty="0">
                  <a:latin typeface="Arial" panose="020B0604020202020204" pitchFamily="34" charset="0"/>
                  <a:cs typeface="Arial" panose="020B0604020202020204" pitchFamily="34" charset="0"/>
                </a:rPr>
                <a:t> Active Site</a:t>
              </a:r>
              <a:endParaRPr lang="en-US" sz="1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ZoneTexte 80">
              <a:extLst>
                <a:ext uri="{FF2B5EF4-FFF2-40B4-BE49-F238E27FC236}">
                  <a16:creationId xmlns:a16="http://schemas.microsoft.com/office/drawing/2014/main" id="{3AC6C661-631F-EE07-71CC-48EC9E345276}"/>
                </a:ext>
              </a:extLst>
            </p:cNvPr>
            <p:cNvSpPr txBox="1"/>
            <p:nvPr/>
          </p:nvSpPr>
          <p:spPr>
            <a:xfrm>
              <a:off x="4769765" y="4786895"/>
              <a:ext cx="1691813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2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eanut</a:t>
              </a:r>
              <a:r>
                <a:rPr lang="fr-FR" sz="20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2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oil</a:t>
              </a:r>
              <a:r>
                <a:rPr lang="fr-FR" sz="20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fr-FR" sz="2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extract</a:t>
              </a:r>
              <a:r>
                <a:rPr lang="fr-FR" sz="20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DZ" sz="2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451672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97</TotalTime>
  <Words>30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anene</dc:creator>
  <cp:lastModifiedBy>Dr. Ahmed Barhoum</cp:lastModifiedBy>
  <cp:revision>12</cp:revision>
  <dcterms:created xsi:type="dcterms:W3CDTF">2024-09-20T16:48:14Z</dcterms:created>
  <dcterms:modified xsi:type="dcterms:W3CDTF">2024-09-22T21:09:06Z</dcterms:modified>
</cp:coreProperties>
</file>